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83" r:id="rId23"/>
    <p:sldId id="278" r:id="rId24"/>
    <p:sldId id="279" r:id="rId25"/>
    <p:sldId id="280" r:id="rId26"/>
    <p:sldId id="281" r:id="rId27"/>
    <p:sldId id="282" r:id="rId28"/>
    <p:sldId id="284" r:id="rId2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3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18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3492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3572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9295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2754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7105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2212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5612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69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136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8954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3401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3D2E8D-3360-426B-A5DA-5E9853D5E67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E17BC6-7C7C-44F4-8071-2C04DBC64E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1697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24. Patient 1 </a:t>
            </a:r>
          </a:p>
        </p:txBody>
      </p:sp>
      <p:pic>
        <p:nvPicPr>
          <p:cNvPr id="6" name="Inhaltsplatzhalter 5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1269" y="3925102"/>
            <a:ext cx="352381" cy="152381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54547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45394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3. Patient 10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8403" y="3925102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58481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8559" y="3925102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167403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4. Patient 11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62662" y="1924154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9549" y="3925102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58482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7415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836327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5. Patient 12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9549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6267" y="3987540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897371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6. Patient 13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9549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7335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0905" y="400129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374349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7. Patient 14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9549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38080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6267" y="3960485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02603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8. Patient 15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8403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58481" y="3925102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8559" y="3925103"/>
            <a:ext cx="352381" cy="1523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031525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9. Patient 16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7830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41424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826502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40. Patient 17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5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8976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1920" y="3928653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84864" y="3928653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020677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8650" y="383980"/>
            <a:ext cx="7886700" cy="1325563"/>
          </a:xfrm>
        </p:spPr>
        <p:txBody>
          <a:bodyPr/>
          <a:lstStyle/>
          <a:p>
            <a:r>
              <a:rPr lang="de-DE" dirty="0"/>
              <a:t>Figure S41. Patient 18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4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1269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30200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79131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566903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42. Patient 19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43809" y="1924154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8976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6840" y="3930204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4345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25. Patient 2</a:t>
            </a:r>
          </a:p>
        </p:txBody>
      </p:sp>
      <p:pic>
        <p:nvPicPr>
          <p:cNvPr id="6" name="Inhaltsplatzhalter 5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1269" y="3925102"/>
            <a:ext cx="352381" cy="152381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20774" y="3925102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60279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752075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43. Patient 20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5537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60279" y="3939630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798742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44. Patient 21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7829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7987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707450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45. Patient 22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1120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77561" y="3939630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648254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46. Patient 23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1121" y="3911350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6987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577960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47. Patient 24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9401" y="3920777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6415" y="3920776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468328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48. Patient 25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4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7830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7986" y="3949057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12715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49. Patient 26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9549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4144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095889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50. Patient 27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4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0547" y="3930204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05290" y="3930204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7727446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51. Patient 28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9401" y="3925101"/>
            <a:ext cx="352381" cy="15238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5069" y="3893271"/>
            <a:ext cx="417338" cy="180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91022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26. Patient 3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0696" y="3925102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45120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1171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27. Patient 4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9549" y="3925102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6267" y="3925102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96713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28. Patient 5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9549" y="3925102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7335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45121" y="3925100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43853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29. Patient 6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7256" y="3925102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6188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79132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67436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0. Patient 7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8976" y="3925102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39628" y="3925101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60280" y="3925101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35017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1. Patient 8</a:t>
            </a:r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0696" y="3925102"/>
            <a:ext cx="352381" cy="152381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9054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7412" y="3925102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07567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Figure S32. Patient 9</a:t>
            </a:r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28650" y="1924157"/>
            <a:ext cx="7886700" cy="4154273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8402" y="3925102"/>
            <a:ext cx="352381" cy="15238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7908" y="3925102"/>
            <a:ext cx="352381" cy="15238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7414" y="3925102"/>
            <a:ext cx="352381" cy="152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4041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0</Words>
  <Application>Microsoft Office PowerPoint</Application>
  <PresentationFormat>Bildschirmpräsentation (4:3)</PresentationFormat>
  <Paragraphs>28</Paragraphs>
  <Slides>2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8</vt:i4>
      </vt:variant>
    </vt:vector>
  </HeadingPairs>
  <TitlesOfParts>
    <vt:vector size="32" baseType="lpstr">
      <vt:lpstr>Arial</vt:lpstr>
      <vt:lpstr>Calibri</vt:lpstr>
      <vt:lpstr>Calibri Light</vt:lpstr>
      <vt:lpstr>Office</vt:lpstr>
      <vt:lpstr>Figure S24. Patient 1 </vt:lpstr>
      <vt:lpstr>Figure S25. Patient 2</vt:lpstr>
      <vt:lpstr>Figure S26. Patient 3</vt:lpstr>
      <vt:lpstr>Figure S27. Patient 4</vt:lpstr>
      <vt:lpstr>Figure S28. Patient 5</vt:lpstr>
      <vt:lpstr>Figure S29. Patient 6</vt:lpstr>
      <vt:lpstr>Figure S30. Patient 7</vt:lpstr>
      <vt:lpstr>Figure S31. Patient 8</vt:lpstr>
      <vt:lpstr>Figure S32. Patient 9</vt:lpstr>
      <vt:lpstr>Figure S33. Patient 10</vt:lpstr>
      <vt:lpstr>Figure S34. Patient 11</vt:lpstr>
      <vt:lpstr>Figure S35. Patient 12</vt:lpstr>
      <vt:lpstr>Figure S36. Patient 13</vt:lpstr>
      <vt:lpstr>Figure S37. Patient 14</vt:lpstr>
      <vt:lpstr>Figure S38. Patient 15</vt:lpstr>
      <vt:lpstr>Figure S39. Patient 16</vt:lpstr>
      <vt:lpstr>Figure S40. Patient 17</vt:lpstr>
      <vt:lpstr>Figure S41. Patient 18</vt:lpstr>
      <vt:lpstr>Figure S42. Patient 19</vt:lpstr>
      <vt:lpstr>Figure S43. Patient 20</vt:lpstr>
      <vt:lpstr>Figure S44. Patient 21</vt:lpstr>
      <vt:lpstr>Figure S45. Patient 22</vt:lpstr>
      <vt:lpstr>Figure S46. Patient 23</vt:lpstr>
      <vt:lpstr>Figure S47. Patient 24</vt:lpstr>
      <vt:lpstr>Figure S48. Patient 25</vt:lpstr>
      <vt:lpstr>Figure S49. Patient 26</vt:lpstr>
      <vt:lpstr>Figure S50. Patient 27</vt:lpstr>
      <vt:lpstr>Figure S51. Patient 28</vt:lpstr>
    </vt:vector>
  </TitlesOfParts>
  <Company>IT Verbund IMISE/ZK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Yuri Kheifetz</dc:creator>
  <cp:lastModifiedBy>Knödler, Maren</cp:lastModifiedBy>
  <cp:revision>14</cp:revision>
  <dcterms:created xsi:type="dcterms:W3CDTF">2022-06-30T13:43:13Z</dcterms:created>
  <dcterms:modified xsi:type="dcterms:W3CDTF">2022-12-22T07:28:00Z</dcterms:modified>
</cp:coreProperties>
</file>